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1" d="100"/>
          <a:sy n="111" d="100"/>
        </p:scale>
        <p:origin x="-894" y="-1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088189801005173"/>
          <c:y val="5.0487655822361512E-2"/>
          <c:w val="0.75127317914609848"/>
          <c:h val="0.85747952756275447"/>
        </c:manualLayout>
      </c:layout>
      <c:barChart>
        <c:barDir val="bar"/>
        <c:grouping val="clustered"/>
        <c:varyColors val="0"/>
        <c:ser>
          <c:idx val="0"/>
          <c:order val="0"/>
          <c:invertIfNegative val="0"/>
          <c:cat>
            <c:strRef>
              <c:f>'Top-Hit'!$B$46:$B$54</c:f>
              <c:strCache>
                <c:ptCount val="9"/>
                <c:pt idx="0">
                  <c:v>Melampsora larici-populina</c:v>
                </c:pt>
                <c:pt idx="1">
                  <c:v>Puccinia graminis</c:v>
                </c:pt>
                <c:pt idx="2">
                  <c:v>Baudoinia compniacensis</c:v>
                </c:pt>
                <c:pt idx="3">
                  <c:v>Dothistroma septosporum</c:v>
                </c:pt>
                <c:pt idx="4">
                  <c:v>Pseudocercospora fijiensis</c:v>
                </c:pt>
                <c:pt idx="5">
                  <c:v>Zymoseptoria tritici</c:v>
                </c:pt>
                <c:pt idx="6">
                  <c:v>Sphaerulina musiva</c:v>
                </c:pt>
                <c:pt idx="7">
                  <c:v>Coniosporium apollinis</c:v>
                </c:pt>
                <c:pt idx="8">
                  <c:v>others</c:v>
                </c:pt>
              </c:strCache>
            </c:strRef>
          </c:cat>
          <c:val>
            <c:numRef>
              <c:f>'Top-Hit'!$C$46:$C$54</c:f>
              <c:numCache>
                <c:formatCode>General</c:formatCode>
                <c:ptCount val="9"/>
                <c:pt idx="0">
                  <c:v>62.81053717071341</c:v>
                </c:pt>
                <c:pt idx="1">
                  <c:v>15.205774819536892</c:v>
                </c:pt>
                <c:pt idx="2">
                  <c:v>1.0124683603637386</c:v>
                </c:pt>
                <c:pt idx="3">
                  <c:v>0.92809599700009371</c:v>
                </c:pt>
                <c:pt idx="4">
                  <c:v>0.75935127027280402</c:v>
                </c:pt>
                <c:pt idx="5">
                  <c:v>0.74060185619199392</c:v>
                </c:pt>
                <c:pt idx="6">
                  <c:v>0.6281053717071341</c:v>
                </c:pt>
                <c:pt idx="7">
                  <c:v>0.58123183650510923</c:v>
                </c:pt>
                <c:pt idx="8">
                  <c:v>17.333833317708823</c:v>
                </c:pt>
              </c:numCache>
            </c:numRef>
          </c:val>
        </c:ser>
        <c:ser>
          <c:idx val="1"/>
          <c:order val="1"/>
          <c:invertIfNegative val="0"/>
          <c:cat>
            <c:strRef>
              <c:f>'Top-Hit'!$B$46:$B$54</c:f>
              <c:strCache>
                <c:ptCount val="9"/>
                <c:pt idx="0">
                  <c:v>Melampsora larici-populina</c:v>
                </c:pt>
                <c:pt idx="1">
                  <c:v>Puccinia graminis</c:v>
                </c:pt>
                <c:pt idx="2">
                  <c:v>Baudoinia compniacensis</c:v>
                </c:pt>
                <c:pt idx="3">
                  <c:v>Dothistroma septosporum</c:v>
                </c:pt>
                <c:pt idx="4">
                  <c:v>Pseudocercospora fijiensis</c:v>
                </c:pt>
                <c:pt idx="5">
                  <c:v>Zymoseptoria tritici</c:v>
                </c:pt>
                <c:pt idx="6">
                  <c:v>Sphaerulina musiva</c:v>
                </c:pt>
                <c:pt idx="7">
                  <c:v>Coniosporium apollinis</c:v>
                </c:pt>
                <c:pt idx="8">
                  <c:v>others</c:v>
                </c:pt>
              </c:strCache>
            </c:strRef>
          </c:cat>
          <c:val>
            <c:numRef>
              <c:f>'Top-Hit'!$D$46:$D$54</c:f>
              <c:numCache>
                <c:formatCode>General</c:formatCode>
                <c:ptCount val="9"/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110528"/>
        <c:axId val="41112320"/>
      </c:barChart>
      <c:catAx>
        <c:axId val="41110528"/>
        <c:scaling>
          <c:orientation val="minMax"/>
        </c:scaling>
        <c:delete val="0"/>
        <c:axPos val="l"/>
        <c:majorTickMark val="out"/>
        <c:minorTickMark val="none"/>
        <c:tickLblPos val="nextTo"/>
        <c:txPr>
          <a:bodyPr/>
          <a:lstStyle/>
          <a:p>
            <a:pPr>
              <a:defRPr b="1" i="1"/>
            </a:pPr>
            <a:endParaRPr lang="en-US"/>
          </a:p>
        </c:txPr>
        <c:crossAx val="41112320"/>
        <c:crosses val="autoZero"/>
        <c:auto val="1"/>
        <c:lblAlgn val="ctr"/>
        <c:lblOffset val="100"/>
        <c:noMultiLvlLbl val="0"/>
      </c:catAx>
      <c:valAx>
        <c:axId val="41112320"/>
        <c:scaling>
          <c:orientation val="minMax"/>
        </c:scaling>
        <c:delete val="0"/>
        <c:axPos val="b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 b="1"/>
            </a:pPr>
            <a:endParaRPr lang="en-US"/>
          </a:p>
        </c:txPr>
        <c:crossAx val="411105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91534F-E876-40B4-B596-4B4DC505FA1D}" type="datetimeFigureOut">
              <a:rPr lang="en-CA" smtClean="0"/>
              <a:t>2015-03-05</a:t>
            </a:fld>
            <a:endParaRPr lang="en-CA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46DC-B08C-4F9C-9536-A1C6510DF82A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7278601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91534F-E876-40B4-B596-4B4DC505FA1D}" type="datetimeFigureOut">
              <a:rPr lang="en-CA" smtClean="0"/>
              <a:t>2015-03-05</a:t>
            </a:fld>
            <a:endParaRPr lang="en-CA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46DC-B08C-4F9C-9536-A1C6510DF82A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1508949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91534F-E876-40B4-B596-4B4DC505FA1D}" type="datetimeFigureOut">
              <a:rPr lang="en-CA" smtClean="0"/>
              <a:t>2015-03-05</a:t>
            </a:fld>
            <a:endParaRPr lang="en-CA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46DC-B08C-4F9C-9536-A1C6510DF82A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1404368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91534F-E876-40B4-B596-4B4DC505FA1D}" type="datetimeFigureOut">
              <a:rPr lang="en-CA" smtClean="0"/>
              <a:t>2015-03-05</a:t>
            </a:fld>
            <a:endParaRPr lang="en-CA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46DC-B08C-4F9C-9536-A1C6510DF82A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2567880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91534F-E876-40B4-B596-4B4DC505FA1D}" type="datetimeFigureOut">
              <a:rPr lang="en-CA" smtClean="0"/>
              <a:t>2015-03-05</a:t>
            </a:fld>
            <a:endParaRPr lang="en-CA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46DC-B08C-4F9C-9536-A1C6510DF82A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512456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91534F-E876-40B4-B596-4B4DC505FA1D}" type="datetimeFigureOut">
              <a:rPr lang="en-CA" smtClean="0"/>
              <a:t>2015-03-05</a:t>
            </a:fld>
            <a:endParaRPr lang="en-CA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46DC-B08C-4F9C-9536-A1C6510DF82A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082501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91534F-E876-40B4-B596-4B4DC505FA1D}" type="datetimeFigureOut">
              <a:rPr lang="en-CA" smtClean="0"/>
              <a:t>2015-03-05</a:t>
            </a:fld>
            <a:endParaRPr lang="en-CA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46DC-B08C-4F9C-9536-A1C6510DF82A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4277629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91534F-E876-40B4-B596-4B4DC505FA1D}" type="datetimeFigureOut">
              <a:rPr lang="en-CA" smtClean="0"/>
              <a:t>2015-03-05</a:t>
            </a:fld>
            <a:endParaRPr lang="en-CA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46DC-B08C-4F9C-9536-A1C6510DF82A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9359029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91534F-E876-40B4-B596-4B4DC505FA1D}" type="datetimeFigureOut">
              <a:rPr lang="en-CA" smtClean="0"/>
              <a:t>2015-03-05</a:t>
            </a:fld>
            <a:endParaRPr lang="en-CA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46DC-B08C-4F9C-9536-A1C6510DF82A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4362653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91534F-E876-40B4-B596-4B4DC505FA1D}" type="datetimeFigureOut">
              <a:rPr lang="en-CA" smtClean="0"/>
              <a:t>2015-03-05</a:t>
            </a:fld>
            <a:endParaRPr lang="en-CA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46DC-B08C-4F9C-9536-A1C6510DF82A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5977534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91534F-E876-40B4-B596-4B4DC505FA1D}" type="datetimeFigureOut">
              <a:rPr lang="en-CA" smtClean="0"/>
              <a:t>2015-03-05</a:t>
            </a:fld>
            <a:endParaRPr lang="en-CA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46DC-B08C-4F9C-9536-A1C6510DF82A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210173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91534F-E876-40B4-B596-4B4DC505FA1D}" type="datetimeFigureOut">
              <a:rPr lang="en-CA" smtClean="0"/>
              <a:t>2015-03-05</a:t>
            </a:fld>
            <a:endParaRPr lang="en-CA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9B46DC-B08C-4F9C-9536-A1C6510DF82A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74202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0885304"/>
              </p:ext>
            </p:extLst>
          </p:nvPr>
        </p:nvGraphicFramePr>
        <p:xfrm>
          <a:off x="1691680" y="1916832"/>
          <a:ext cx="5112567" cy="19573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347864" y="3861048"/>
            <a:ext cx="3120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 smtClean="0"/>
              <a:t>Percentage of total sequences with BLAST hits</a:t>
            </a:r>
            <a:endParaRPr lang="en-CA" sz="1200" b="1" dirty="0"/>
          </a:p>
        </p:txBody>
      </p:sp>
      <p:sp>
        <p:nvSpPr>
          <p:cNvPr id="2" name="TextBox 1"/>
          <p:cNvSpPr txBox="1"/>
          <p:nvPr/>
        </p:nvSpPr>
        <p:spPr>
          <a:xfrm>
            <a:off x="2133929" y="4509120"/>
            <a:ext cx="49685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/>
              <a:t>Figure </a:t>
            </a:r>
            <a:r>
              <a:rPr lang="en-CA" sz="1200" b="1" dirty="0" smtClean="0"/>
              <a:t>S1:  </a:t>
            </a:r>
            <a:r>
              <a:rPr lang="en-CA" sz="1200" b="1" dirty="0"/>
              <a:t>Top-hit species distribution for the </a:t>
            </a:r>
            <a:r>
              <a:rPr lang="en-CA" sz="1200" b="1" i="1" dirty="0" err="1"/>
              <a:t>Cronartium</a:t>
            </a:r>
            <a:r>
              <a:rPr lang="en-CA" sz="1200" b="1" i="1" dirty="0"/>
              <a:t> </a:t>
            </a:r>
            <a:r>
              <a:rPr lang="en-CA" sz="1200" b="1" i="1" dirty="0" err="1"/>
              <a:t>ribicola</a:t>
            </a:r>
            <a:r>
              <a:rPr lang="en-CA" sz="1200" b="1" i="1" dirty="0"/>
              <a:t> </a:t>
            </a:r>
            <a:r>
              <a:rPr lang="en-CA" sz="1200" b="1" dirty="0" smtClean="0"/>
              <a:t>reference </a:t>
            </a:r>
            <a:r>
              <a:rPr lang="en-CA" sz="1200" b="1" dirty="0" err="1" smtClean="0"/>
              <a:t>transcriptome</a:t>
            </a:r>
            <a:r>
              <a:rPr lang="en-CA" sz="1200" b="1" dirty="0" smtClean="0"/>
              <a:t> measured </a:t>
            </a:r>
            <a:r>
              <a:rPr lang="en-CA" sz="1200" b="1" dirty="0"/>
              <a:t>by BLASTX using Blast2GO program.</a:t>
            </a:r>
          </a:p>
        </p:txBody>
      </p:sp>
    </p:spTree>
    <p:extLst>
      <p:ext uri="{BB962C8B-B14F-4D97-AF65-F5344CB8AC3E}">
        <p14:creationId xmlns:p14="http://schemas.microsoft.com/office/powerpoint/2010/main" val="21658608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6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RCan / RNCa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Jun-Jun</dc:creator>
  <cp:lastModifiedBy>Liu, Jun-Jun</cp:lastModifiedBy>
  <cp:revision>4</cp:revision>
  <dcterms:created xsi:type="dcterms:W3CDTF">2014-12-12T23:45:46Z</dcterms:created>
  <dcterms:modified xsi:type="dcterms:W3CDTF">2015-03-05T19:40:53Z</dcterms:modified>
</cp:coreProperties>
</file>